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6" r:id="rId2"/>
  </p:sldIdLst>
  <p:sldSz cx="6858000" cy="9144000" type="screen4x3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40FF"/>
    <a:srgbClr val="73FEFF"/>
    <a:srgbClr val="FFD57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6588"/>
    <p:restoredTop sz="94972"/>
  </p:normalViewPr>
  <p:slideViewPr>
    <p:cSldViewPr snapToGrid="0" snapToObjects="1">
      <p:cViewPr varScale="1">
        <p:scale>
          <a:sx n="69" d="100"/>
          <a:sy n="69" d="100"/>
        </p:scale>
        <p:origin x="3288" y="18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89FF15C-26B8-F04C-993E-C468BCD5D060}" type="datetimeFigureOut">
              <a:rPr lang="fr-FR" smtClean="0"/>
              <a:t>30/06/2025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3973BEE-B6B3-604B-9994-DF23EEECDD5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896697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3973BEE-B6B3-604B-9994-DF23EEECDD5A}" type="slidenum">
              <a:rPr lang="fr-FR" smtClean="0"/>
              <a:t>1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3022971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Cliquez pour modifier le style des sous-titres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DF06CB-91B2-524E-89EA-ACA55D725581}" type="datetimeFigureOut">
              <a:rPr lang="fr-FR" smtClean="0"/>
              <a:t>30/06/202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BFF4A7-BFC3-DE40-8F01-2D1161B72A1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746888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DF06CB-91B2-524E-89EA-ACA55D725581}" type="datetimeFigureOut">
              <a:rPr lang="fr-FR" smtClean="0"/>
              <a:t>30/06/202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BFF4A7-BFC3-DE40-8F01-2D1161B72A1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396215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DF06CB-91B2-524E-89EA-ACA55D725581}" type="datetimeFigureOut">
              <a:rPr lang="fr-FR" smtClean="0"/>
              <a:t>30/06/202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BFF4A7-BFC3-DE40-8F01-2D1161B72A1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011709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DF06CB-91B2-524E-89EA-ACA55D725581}" type="datetimeFigureOut">
              <a:rPr lang="fr-FR" smtClean="0"/>
              <a:t>30/06/202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BFF4A7-BFC3-DE40-8F01-2D1161B72A1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605261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DF06CB-91B2-524E-89EA-ACA55D725581}" type="datetimeFigureOut">
              <a:rPr lang="fr-FR" smtClean="0"/>
              <a:t>30/06/202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BFF4A7-BFC3-DE40-8F01-2D1161B72A1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445294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DF06CB-91B2-524E-89EA-ACA55D725581}" type="datetimeFigureOut">
              <a:rPr lang="fr-FR" smtClean="0"/>
              <a:t>30/06/2025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BFF4A7-BFC3-DE40-8F01-2D1161B72A1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567449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DF06CB-91B2-524E-89EA-ACA55D725581}" type="datetimeFigureOut">
              <a:rPr lang="fr-FR" smtClean="0"/>
              <a:t>30/06/2025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BFF4A7-BFC3-DE40-8F01-2D1161B72A1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494863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DF06CB-91B2-524E-89EA-ACA55D725581}" type="datetimeFigureOut">
              <a:rPr lang="fr-FR" smtClean="0"/>
              <a:t>30/06/2025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BFF4A7-BFC3-DE40-8F01-2D1161B72A1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665008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DF06CB-91B2-524E-89EA-ACA55D725581}" type="datetimeFigureOut">
              <a:rPr lang="fr-FR" smtClean="0"/>
              <a:t>30/06/2025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BFF4A7-BFC3-DE40-8F01-2D1161B72A1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583114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DF06CB-91B2-524E-89EA-ACA55D725581}" type="datetimeFigureOut">
              <a:rPr lang="fr-FR" smtClean="0"/>
              <a:t>30/06/2025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BFF4A7-BFC3-DE40-8F01-2D1161B72A1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143599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DF06CB-91B2-524E-89EA-ACA55D725581}" type="datetimeFigureOut">
              <a:rPr lang="fr-FR" smtClean="0"/>
              <a:t>30/06/2025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BFF4A7-BFC3-DE40-8F01-2D1161B72A1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836912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DF06CB-91B2-524E-89EA-ACA55D725581}" type="datetimeFigureOut">
              <a:rPr lang="fr-FR" smtClean="0"/>
              <a:t>30/06/202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BFF4A7-BFC3-DE40-8F01-2D1161B72A1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838859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au 3">
            <a:extLst>
              <a:ext uri="{FF2B5EF4-FFF2-40B4-BE49-F238E27FC236}">
                <a16:creationId xmlns:a16="http://schemas.microsoft.com/office/drawing/2014/main" id="{5CE25381-EEBF-A4DA-9F6A-27472077131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09532506"/>
              </p:ext>
            </p:extLst>
          </p:nvPr>
        </p:nvGraphicFramePr>
        <p:xfrm>
          <a:off x="915909" y="2040688"/>
          <a:ext cx="1719359" cy="60960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82826">
                  <a:extLst>
                    <a:ext uri="{9D8B030D-6E8A-4147-A177-3AD203B41FA5}">
                      <a16:colId xmlns:a16="http://schemas.microsoft.com/office/drawing/2014/main" val="1477797383"/>
                    </a:ext>
                  </a:extLst>
                </a:gridCol>
                <a:gridCol w="222378">
                  <a:extLst>
                    <a:ext uri="{9D8B030D-6E8A-4147-A177-3AD203B41FA5}">
                      <a16:colId xmlns:a16="http://schemas.microsoft.com/office/drawing/2014/main" val="407517225"/>
                    </a:ext>
                  </a:extLst>
                </a:gridCol>
                <a:gridCol w="222378">
                  <a:extLst>
                    <a:ext uri="{9D8B030D-6E8A-4147-A177-3AD203B41FA5}">
                      <a16:colId xmlns:a16="http://schemas.microsoft.com/office/drawing/2014/main" val="704800411"/>
                    </a:ext>
                  </a:extLst>
                </a:gridCol>
                <a:gridCol w="222378">
                  <a:extLst>
                    <a:ext uri="{9D8B030D-6E8A-4147-A177-3AD203B41FA5}">
                      <a16:colId xmlns:a16="http://schemas.microsoft.com/office/drawing/2014/main" val="1159908077"/>
                    </a:ext>
                  </a:extLst>
                </a:gridCol>
                <a:gridCol w="222378">
                  <a:extLst>
                    <a:ext uri="{9D8B030D-6E8A-4147-A177-3AD203B41FA5}">
                      <a16:colId xmlns:a16="http://schemas.microsoft.com/office/drawing/2014/main" val="1835283840"/>
                    </a:ext>
                  </a:extLst>
                </a:gridCol>
                <a:gridCol w="222378">
                  <a:extLst>
                    <a:ext uri="{9D8B030D-6E8A-4147-A177-3AD203B41FA5}">
                      <a16:colId xmlns:a16="http://schemas.microsoft.com/office/drawing/2014/main" val="1556753772"/>
                    </a:ext>
                  </a:extLst>
                </a:gridCol>
                <a:gridCol w="224643">
                  <a:extLst>
                    <a:ext uri="{9D8B030D-6E8A-4147-A177-3AD203B41FA5}">
                      <a16:colId xmlns:a16="http://schemas.microsoft.com/office/drawing/2014/main" val="2784289434"/>
                    </a:ext>
                  </a:extLst>
                </a:gridCol>
              </a:tblGrid>
              <a:tr h="84748">
                <a:tc>
                  <a:txBody>
                    <a:bodyPr/>
                    <a:lstStyle/>
                    <a:p>
                      <a:pPr algn="ctr"/>
                      <a:endParaRPr lang="en-GB" sz="800" b="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5">
                  <a:txBody>
                    <a:bodyPr/>
                    <a:lstStyle/>
                    <a:p>
                      <a:pPr algn="ctr"/>
                      <a:r>
                        <a:rPr lang="en-GB" sz="800" b="0" dirty="0">
                          <a:solidFill>
                            <a:schemeClr val="tx1"/>
                          </a:solidFill>
                        </a:rPr>
                        <a:t>6F06 (CB1/2)</a:t>
                      </a: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/>
                      <a:endParaRPr lang="en-GB" sz="80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GB" sz="80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n-GB" sz="800" b="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75050104"/>
                  </a:ext>
                </a:extLst>
              </a:tr>
              <a:tr h="84748">
                <a:tc>
                  <a:txBody>
                    <a:bodyPr/>
                    <a:lstStyle/>
                    <a:p>
                      <a:pPr algn="ctr"/>
                      <a:endParaRPr lang="en-GB" sz="800" b="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GB" sz="800" b="0" dirty="0">
                          <a:solidFill>
                            <a:schemeClr val="tx1"/>
                          </a:solidFill>
                        </a:rPr>
                        <a:t>sg-1</a:t>
                      </a: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GB" sz="80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GB" sz="800" b="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GB" sz="800" b="0" dirty="0">
                          <a:solidFill>
                            <a:schemeClr val="tx1"/>
                          </a:solidFill>
                        </a:rPr>
                        <a:t>sg-2</a:t>
                      </a:r>
                    </a:p>
                  </a:txBody>
                  <a:tcPr marL="0" marR="0" marT="0" marB="0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GB" sz="80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GB" sz="800" b="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98958912"/>
                  </a:ext>
                </a:extLst>
              </a:tr>
              <a:tr h="84748">
                <a:tc>
                  <a:txBody>
                    <a:bodyPr/>
                    <a:lstStyle/>
                    <a:p>
                      <a:pPr algn="ctr"/>
                      <a:r>
                        <a:rPr lang="en-GB" sz="800" b="0" dirty="0">
                          <a:solidFill>
                            <a:schemeClr val="tx1"/>
                          </a:solidFill>
                        </a:rPr>
                        <a:t>sgRNA</a:t>
                      </a: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b="0" dirty="0">
                          <a:solidFill>
                            <a:schemeClr val="tx1"/>
                          </a:solidFill>
                        </a:rPr>
                        <a:t>+</a:t>
                      </a: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b="0" dirty="0">
                          <a:solidFill>
                            <a:schemeClr val="tx1"/>
                          </a:solidFill>
                        </a:rPr>
                        <a:t>+</a:t>
                      </a:r>
                    </a:p>
                  </a:txBody>
                  <a:tcPr marL="0" marR="0" marT="0" marB="0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b="0" dirty="0">
                          <a:solidFill>
                            <a:schemeClr val="tx1"/>
                          </a:solidFill>
                        </a:rPr>
                        <a:t>-</a:t>
                      </a:r>
                    </a:p>
                  </a:txBody>
                  <a:tcPr marL="0" marR="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b="0" dirty="0">
                          <a:solidFill>
                            <a:schemeClr val="tx1"/>
                          </a:solidFill>
                        </a:rPr>
                        <a:t>+</a:t>
                      </a:r>
                    </a:p>
                  </a:txBody>
                  <a:tcPr marL="0" marR="0" marT="0" marB="0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b="0" dirty="0">
                          <a:solidFill>
                            <a:schemeClr val="tx1"/>
                          </a:solidFill>
                        </a:rPr>
                        <a:t>+</a:t>
                      </a:r>
                    </a:p>
                  </a:txBody>
                  <a:tcPr marL="0" marR="0" marT="0" marB="0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GB" sz="800" b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96737124"/>
                  </a:ext>
                </a:extLst>
              </a:tr>
              <a:tr h="84748">
                <a:tc>
                  <a:txBody>
                    <a:bodyPr/>
                    <a:lstStyle/>
                    <a:p>
                      <a:pPr algn="ctr"/>
                      <a:r>
                        <a:rPr lang="en-GB" sz="800" b="0" dirty="0">
                          <a:solidFill>
                            <a:schemeClr val="tx1"/>
                          </a:solidFill>
                        </a:rPr>
                        <a:t>Cas9</a:t>
                      </a: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b="0" dirty="0">
                          <a:solidFill>
                            <a:schemeClr val="tx1"/>
                          </a:solidFill>
                        </a:rPr>
                        <a:t>+</a:t>
                      </a: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b="0" dirty="0">
                          <a:solidFill>
                            <a:schemeClr val="tx1"/>
                          </a:solidFill>
                        </a:rPr>
                        <a:t>-</a:t>
                      </a:r>
                    </a:p>
                  </a:txBody>
                  <a:tcPr marL="0" marR="0" marT="0" marB="0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b="0" dirty="0">
                          <a:solidFill>
                            <a:schemeClr val="tx1"/>
                          </a:solidFill>
                        </a:rPr>
                        <a:t>+</a:t>
                      </a:r>
                    </a:p>
                  </a:txBody>
                  <a:tcPr marL="0" marR="0" marT="0" marB="0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b="0" dirty="0">
                          <a:solidFill>
                            <a:schemeClr val="tx1"/>
                          </a:solidFill>
                        </a:rPr>
                        <a:t>+</a:t>
                      </a:r>
                    </a:p>
                  </a:txBody>
                  <a:tcPr marL="0" marR="0" marT="0" marB="0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b="0" dirty="0">
                          <a:solidFill>
                            <a:schemeClr val="tx1"/>
                          </a:solidFill>
                        </a:rPr>
                        <a:t>-</a:t>
                      </a:r>
                    </a:p>
                  </a:txBody>
                  <a:tcPr marL="0" marR="0" marT="0" marB="0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GB" sz="800" b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33477316"/>
                  </a:ext>
                </a:extLst>
              </a:tr>
              <a:tr h="84748">
                <a:tc>
                  <a:txBody>
                    <a:bodyPr/>
                    <a:lstStyle/>
                    <a:p>
                      <a:pPr algn="ctr"/>
                      <a:r>
                        <a:rPr lang="en-GB" sz="800" b="0" dirty="0">
                          <a:solidFill>
                            <a:schemeClr val="tx1"/>
                          </a:solidFill>
                        </a:rPr>
                        <a:t>DNA</a:t>
                      </a: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b="0" dirty="0">
                          <a:solidFill>
                            <a:schemeClr val="tx1"/>
                          </a:solidFill>
                        </a:rPr>
                        <a:t>+</a:t>
                      </a: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b="0" dirty="0">
                          <a:solidFill>
                            <a:schemeClr val="tx1"/>
                          </a:solidFill>
                        </a:rPr>
                        <a:t>+</a:t>
                      </a:r>
                    </a:p>
                  </a:txBody>
                  <a:tcPr marL="0" marR="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b="0" dirty="0">
                          <a:solidFill>
                            <a:schemeClr val="tx1"/>
                          </a:solidFill>
                        </a:rPr>
                        <a:t>+</a:t>
                      </a:r>
                    </a:p>
                  </a:txBody>
                  <a:tcPr marL="0" marR="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b="0" dirty="0">
                          <a:solidFill>
                            <a:schemeClr val="tx1"/>
                          </a:solidFill>
                        </a:rPr>
                        <a:t>+</a:t>
                      </a:r>
                    </a:p>
                  </a:txBody>
                  <a:tcPr marL="0" marR="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b="0" dirty="0">
                          <a:solidFill>
                            <a:schemeClr val="tx1"/>
                          </a:solidFill>
                        </a:rPr>
                        <a:t>+</a:t>
                      </a:r>
                    </a:p>
                  </a:txBody>
                  <a:tcPr marL="0" marR="0" marT="0" marB="0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b="0" dirty="0">
                          <a:solidFill>
                            <a:schemeClr val="tx1"/>
                          </a:solidFill>
                        </a:rPr>
                        <a:t>M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63868572"/>
                  </a:ext>
                </a:extLst>
              </a:tr>
            </a:tbl>
          </a:graphicData>
        </a:graphic>
      </p:graphicFrame>
      <p:grpSp>
        <p:nvGrpSpPr>
          <p:cNvPr id="5" name="Groupe 4">
            <a:extLst>
              <a:ext uri="{FF2B5EF4-FFF2-40B4-BE49-F238E27FC236}">
                <a16:creationId xmlns:a16="http://schemas.microsoft.com/office/drawing/2014/main" id="{6A4FA045-FBEB-6D26-80F0-D49E257B6BEE}"/>
              </a:ext>
            </a:extLst>
          </p:cNvPr>
          <p:cNvGrpSpPr/>
          <p:nvPr/>
        </p:nvGrpSpPr>
        <p:grpSpPr>
          <a:xfrm>
            <a:off x="1248552" y="2666826"/>
            <a:ext cx="1568879" cy="1149550"/>
            <a:chOff x="640891" y="1325501"/>
            <a:chExt cx="2753973" cy="1718322"/>
          </a:xfrm>
        </p:grpSpPr>
        <p:sp>
          <p:nvSpPr>
            <p:cNvPr id="7" name="ZoneTexte 6">
              <a:extLst>
                <a:ext uri="{FF2B5EF4-FFF2-40B4-BE49-F238E27FC236}">
                  <a16:creationId xmlns:a16="http://schemas.microsoft.com/office/drawing/2014/main" id="{D7F277F0-D568-D7D3-4903-984E0B9E9093}"/>
                </a:ext>
              </a:extLst>
            </p:cNvPr>
            <p:cNvSpPr txBox="1"/>
            <p:nvPr/>
          </p:nvSpPr>
          <p:spPr>
            <a:xfrm>
              <a:off x="3070592" y="2491754"/>
              <a:ext cx="324272" cy="55206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endParaRPr lang="en-GB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grpSp>
          <p:nvGrpSpPr>
            <p:cNvPr id="9" name="Groupe 8">
              <a:extLst>
                <a:ext uri="{FF2B5EF4-FFF2-40B4-BE49-F238E27FC236}">
                  <a16:creationId xmlns:a16="http://schemas.microsoft.com/office/drawing/2014/main" id="{647A5B3C-3130-E4C4-B573-313D56E4C1D0}"/>
                </a:ext>
              </a:extLst>
            </p:cNvPr>
            <p:cNvGrpSpPr/>
            <p:nvPr/>
          </p:nvGrpSpPr>
          <p:grpSpPr>
            <a:xfrm>
              <a:off x="640891" y="1325502"/>
              <a:ext cx="1998957" cy="1568919"/>
              <a:chOff x="4195057" y="849061"/>
              <a:chExt cx="1998957" cy="1568919"/>
            </a:xfrm>
          </p:grpSpPr>
          <p:pic>
            <p:nvPicPr>
              <p:cNvPr id="13" name="Image 12" descr="Une image contenant capture d’écran, écran, noir, Rectangle&#10;&#10;Description générée automatiquement">
                <a:extLst>
                  <a:ext uri="{FF2B5EF4-FFF2-40B4-BE49-F238E27FC236}">
                    <a16:creationId xmlns:a16="http://schemas.microsoft.com/office/drawing/2014/main" id="{D27EE469-C0C8-E487-D854-DEA5DFC1720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BEBA8EAE-BF5A-486C-A8C5-ECC9F3942E4B}">
                    <a14:imgProps xmlns:a14="http://schemas.microsoft.com/office/drawing/2010/main">
                      <a14:imgLayer r:embed="rId4">
                        <a14:imgEffect>
                          <a14:sharpenSoften amount="100000"/>
                        </a14:imgEffect>
                        <a14:imgEffect>
                          <a14:brightnessContrast bright="-14000" contrast="20000"/>
                        </a14:imgEffect>
                      </a14:imgLayer>
                    </a14:imgProps>
                  </a:ext>
                </a:extLst>
              </a:blip>
              <a:srcRect l="4637" t="13873" r="82583" b="46485"/>
              <a:stretch/>
            </p:blipFill>
            <p:spPr>
              <a:xfrm>
                <a:off x="4195057" y="849067"/>
                <a:ext cx="889245" cy="1568913"/>
              </a:xfrm>
              <a:prstGeom prst="rect">
                <a:avLst/>
              </a:prstGeom>
            </p:spPr>
          </p:pic>
          <p:pic>
            <p:nvPicPr>
              <p:cNvPr id="14" name="Image 13" descr="Une image contenant capture d’écran, écran, noir, Rectangle&#10;&#10;Description générée automatiquement">
                <a:extLst>
                  <a:ext uri="{FF2B5EF4-FFF2-40B4-BE49-F238E27FC236}">
                    <a16:creationId xmlns:a16="http://schemas.microsoft.com/office/drawing/2014/main" id="{3401EF08-9078-EAAC-5909-1797A6AAC14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BEBA8EAE-BF5A-486C-A8C5-ECC9F3942E4B}">
                    <a14:imgProps xmlns:a14="http://schemas.microsoft.com/office/drawing/2010/main">
                      <a14:imgLayer r:embed="rId4">
                        <a14:imgEffect>
                          <a14:sharpenSoften amount="100000"/>
                        </a14:imgEffect>
                        <a14:imgEffect>
                          <a14:brightnessContrast bright="-14000" contrast="20000"/>
                        </a14:imgEffect>
                      </a14:imgLayer>
                    </a14:imgProps>
                  </a:ext>
                </a:extLst>
              </a:blip>
              <a:srcRect l="28573" t="13873" r="65743" b="46485"/>
              <a:stretch/>
            </p:blipFill>
            <p:spPr>
              <a:xfrm>
                <a:off x="5084303" y="849064"/>
                <a:ext cx="389823" cy="1568913"/>
              </a:xfrm>
              <a:prstGeom prst="rect">
                <a:avLst/>
              </a:prstGeom>
            </p:spPr>
          </p:pic>
          <p:pic>
            <p:nvPicPr>
              <p:cNvPr id="15" name="Image 14" descr="Une image contenant capture d’écran, écran, noir, Rectangle&#10;&#10;Description générée automatiquement">
                <a:extLst>
                  <a:ext uri="{FF2B5EF4-FFF2-40B4-BE49-F238E27FC236}">
                    <a16:creationId xmlns:a16="http://schemas.microsoft.com/office/drawing/2014/main" id="{B04C6F9F-3235-815D-617C-102D6B266D4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BEBA8EAE-BF5A-486C-A8C5-ECC9F3942E4B}">
                    <a14:imgProps xmlns:a14="http://schemas.microsoft.com/office/drawing/2010/main">
                      <a14:imgLayer r:embed="rId4">
                        <a14:imgEffect>
                          <a14:sharpenSoften amount="100000"/>
                        </a14:imgEffect>
                        <a14:imgEffect>
                          <a14:brightnessContrast bright="-14000" contrast="20000"/>
                        </a14:imgEffect>
                      </a14:imgLayer>
                    </a14:imgProps>
                  </a:ext>
                </a:extLst>
              </a:blip>
              <a:srcRect l="17000" t="13873" r="72363" b="46485"/>
              <a:stretch/>
            </p:blipFill>
            <p:spPr>
              <a:xfrm>
                <a:off x="5464535" y="849061"/>
                <a:ext cx="729479" cy="1568913"/>
              </a:xfrm>
              <a:prstGeom prst="rect">
                <a:avLst/>
              </a:prstGeom>
            </p:spPr>
          </p:pic>
        </p:grpSp>
        <p:pic>
          <p:nvPicPr>
            <p:cNvPr id="10" name="Image 9" descr="Une image contenant capture d’écran, écran, noir, Rectangle&#10;&#10;Description générée automatiquement">
              <a:extLst>
                <a:ext uri="{FF2B5EF4-FFF2-40B4-BE49-F238E27FC236}">
                  <a16:creationId xmlns:a16="http://schemas.microsoft.com/office/drawing/2014/main" id="{E25A9E08-24DB-AD16-0C3A-4BC3369CC3C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sharpenSoften amount="100000"/>
                      </a14:imgEffect>
                      <a14:imgEffect>
                        <a14:brightnessContrast bright="-14000" contrast="20000"/>
                      </a14:imgEffect>
                    </a14:imgLayer>
                  </a14:imgProps>
                </a:ext>
              </a:extLst>
            </a:blip>
            <a:srcRect l="34256" t="14509" r="60060" b="45849"/>
            <a:stretch/>
          </p:blipFill>
          <p:spPr>
            <a:xfrm>
              <a:off x="2639847" y="1325501"/>
              <a:ext cx="389823" cy="1568913"/>
            </a:xfrm>
            <a:prstGeom prst="rect">
              <a:avLst/>
            </a:prstGeom>
          </p:spPr>
        </p:pic>
      </p:grpSp>
      <p:sp>
        <p:nvSpPr>
          <p:cNvPr id="2" name="TextBox 3">
            <a:extLst>
              <a:ext uri="{FF2B5EF4-FFF2-40B4-BE49-F238E27FC236}">
                <a16:creationId xmlns:a16="http://schemas.microsoft.com/office/drawing/2014/main" id="{91AF0C5F-97A8-CBE3-C086-EE4A9F619893}"/>
              </a:ext>
            </a:extLst>
          </p:cNvPr>
          <p:cNvSpPr txBox="1"/>
          <p:nvPr/>
        </p:nvSpPr>
        <p:spPr>
          <a:xfrm>
            <a:off x="-41939" y="23038"/>
            <a:ext cx="685799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 algn="ctr">
              <a:lnSpc>
                <a:spcPct val="90000"/>
              </a:lnSpc>
            </a:pPr>
            <a:r>
              <a:rPr lang="fr-FR" sz="1000" b="1" dirty="0" err="1">
                <a:latin typeface="Calibri" panose="020F0502020204030204" pitchFamily="34" charset="0"/>
                <a:cs typeface="Calibri" panose="020F0502020204030204" pitchFamily="34" charset="0"/>
              </a:rPr>
              <a:t>Supplementary</a:t>
            </a:r>
            <a:r>
              <a:rPr lang="fr-FR" sz="1000" b="1" dirty="0">
                <a:latin typeface="Calibri" panose="020F0502020204030204" pitchFamily="34" charset="0"/>
                <a:cs typeface="Calibri" panose="020F0502020204030204" pitchFamily="34" charset="0"/>
              </a:rPr>
              <a:t> Figure S5</a:t>
            </a:r>
            <a:endParaRPr lang="en-GB" sz="10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" name="ZoneTexte 2">
            <a:extLst>
              <a:ext uri="{FF2B5EF4-FFF2-40B4-BE49-F238E27FC236}">
                <a16:creationId xmlns:a16="http://schemas.microsoft.com/office/drawing/2014/main" id="{EC7029A3-0EDC-3028-0AA7-6E6F50AC273E}"/>
              </a:ext>
            </a:extLst>
          </p:cNvPr>
          <p:cNvSpPr txBox="1"/>
          <p:nvPr/>
        </p:nvSpPr>
        <p:spPr>
          <a:xfrm>
            <a:off x="484891" y="513532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Calibri" panose="020F0502020204030204" pitchFamily="34" charset="0"/>
                <a:cs typeface="Calibri" panose="020F0502020204030204" pitchFamily="34" charset="0"/>
              </a:rPr>
              <a:t>A</a:t>
            </a:r>
          </a:p>
        </p:txBody>
      </p:sp>
      <p:grpSp>
        <p:nvGrpSpPr>
          <p:cNvPr id="6" name="Groupe 5">
            <a:extLst>
              <a:ext uri="{FF2B5EF4-FFF2-40B4-BE49-F238E27FC236}">
                <a16:creationId xmlns:a16="http://schemas.microsoft.com/office/drawing/2014/main" id="{FDAE35C8-2507-693D-B950-59CB6495BF6A}"/>
              </a:ext>
            </a:extLst>
          </p:cNvPr>
          <p:cNvGrpSpPr/>
          <p:nvPr/>
        </p:nvGrpSpPr>
        <p:grpSpPr>
          <a:xfrm>
            <a:off x="868741" y="732365"/>
            <a:ext cx="4699355" cy="806466"/>
            <a:chOff x="232509" y="474657"/>
            <a:chExt cx="6193449" cy="806466"/>
          </a:xfrm>
        </p:grpSpPr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id="{91440E62-40E4-A039-5C09-2EC7E8965741}"/>
                </a:ext>
              </a:extLst>
            </p:cNvPr>
            <p:cNvSpPr/>
            <p:nvPr/>
          </p:nvSpPr>
          <p:spPr>
            <a:xfrm>
              <a:off x="232509" y="718059"/>
              <a:ext cx="6177114" cy="563064"/>
            </a:xfrm>
            <a:prstGeom prst="rect">
              <a:avLst/>
            </a:prstGeom>
            <a:solidFill>
              <a:schemeClr val="bg1">
                <a:lumMod val="95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1" name="ZoneTexte 10">
              <a:extLst>
                <a:ext uri="{FF2B5EF4-FFF2-40B4-BE49-F238E27FC236}">
                  <a16:creationId xmlns:a16="http://schemas.microsoft.com/office/drawing/2014/main" id="{93C5C8F9-E3E6-DB75-8E0C-9B17B6DF8CF4}"/>
                </a:ext>
              </a:extLst>
            </p:cNvPr>
            <p:cNvSpPr txBox="1"/>
            <p:nvPr/>
          </p:nvSpPr>
          <p:spPr>
            <a:xfrm>
              <a:off x="248843" y="602304"/>
              <a:ext cx="1816158" cy="123110"/>
            </a:xfrm>
            <a:prstGeom prst="rect">
              <a:avLst/>
            </a:prstGeom>
            <a:noFill/>
          </p:spPr>
          <p:txBody>
            <a:bodyPr wrap="square" lIns="0" tIns="0" rIns="0" bIns="0">
              <a:spAutoFit/>
            </a:bodyPr>
            <a:lstStyle>
              <a:defPPr>
                <a:defRPr lang="fr-FR"/>
              </a:defPPr>
              <a:lvl1pPr algn="ctr">
                <a:defRPr sz="800"/>
              </a:lvl1pPr>
            </a:lstStyle>
            <a:p>
              <a:pPr algn="l"/>
              <a:r>
                <a:rPr lang="fr-FR" dirty="0">
                  <a:latin typeface="Calibri" panose="020F0502020204030204" pitchFamily="34" charset="0"/>
                  <a:cs typeface="Calibri" panose="020F0502020204030204" pitchFamily="34" charset="0"/>
                </a:rPr>
                <a:t>6F06 - Minc3s08477g42291</a:t>
              </a:r>
            </a:p>
          </p:txBody>
        </p:sp>
        <p:grpSp>
          <p:nvGrpSpPr>
            <p:cNvPr id="12" name="Groupe 11">
              <a:extLst>
                <a:ext uri="{FF2B5EF4-FFF2-40B4-BE49-F238E27FC236}">
                  <a16:creationId xmlns:a16="http://schemas.microsoft.com/office/drawing/2014/main" id="{F45B069D-D0E8-3CAD-EDFC-0223C5555FBB}"/>
                </a:ext>
              </a:extLst>
            </p:cNvPr>
            <p:cNvGrpSpPr/>
            <p:nvPr/>
          </p:nvGrpSpPr>
          <p:grpSpPr>
            <a:xfrm>
              <a:off x="789345" y="834819"/>
              <a:ext cx="5620278" cy="402373"/>
              <a:chOff x="637952" y="5354885"/>
              <a:chExt cx="5620278" cy="402373"/>
            </a:xfrm>
          </p:grpSpPr>
          <p:cxnSp>
            <p:nvCxnSpPr>
              <p:cNvPr id="25" name="Connecteur droit 24">
                <a:extLst>
                  <a:ext uri="{FF2B5EF4-FFF2-40B4-BE49-F238E27FC236}">
                    <a16:creationId xmlns:a16="http://schemas.microsoft.com/office/drawing/2014/main" id="{3D654E97-5BDA-5611-C9E0-40F77850A10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40387" y="5465507"/>
                <a:ext cx="5400000" cy="0"/>
              </a:xfrm>
              <a:prstGeom prst="line">
                <a:avLst/>
              </a:prstGeom>
              <a:ln w="12700" cap="rnd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7" name="ZoneTexte 26">
                <a:extLst>
                  <a:ext uri="{FF2B5EF4-FFF2-40B4-BE49-F238E27FC236}">
                    <a16:creationId xmlns:a16="http://schemas.microsoft.com/office/drawing/2014/main" id="{BB9C3EBF-842D-4DF9-A63B-C02ABA91504B}"/>
                  </a:ext>
                </a:extLst>
              </p:cNvPr>
              <p:cNvSpPr txBox="1"/>
              <p:nvPr/>
            </p:nvSpPr>
            <p:spPr>
              <a:xfrm>
                <a:off x="637952" y="5534320"/>
                <a:ext cx="178191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fr-FR" sz="8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5’</a:t>
                </a:r>
              </a:p>
            </p:txBody>
          </p:sp>
          <p:sp>
            <p:nvSpPr>
              <p:cNvPr id="28" name="ZoneTexte 27">
                <a:extLst>
                  <a:ext uri="{FF2B5EF4-FFF2-40B4-BE49-F238E27FC236}">
                    <a16:creationId xmlns:a16="http://schemas.microsoft.com/office/drawing/2014/main" id="{8DCD259E-AD9D-CFAA-8712-D6ABB7798C36}"/>
                  </a:ext>
                </a:extLst>
              </p:cNvPr>
              <p:cNvSpPr txBox="1"/>
              <p:nvPr/>
            </p:nvSpPr>
            <p:spPr>
              <a:xfrm>
                <a:off x="6080039" y="5523694"/>
                <a:ext cx="178191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fr-FR" sz="8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3’</a:t>
                </a:r>
              </a:p>
            </p:txBody>
          </p:sp>
          <p:sp>
            <p:nvSpPr>
              <p:cNvPr id="29" name="Flèche vers la droite 28">
                <a:extLst>
                  <a:ext uri="{FF2B5EF4-FFF2-40B4-BE49-F238E27FC236}">
                    <a16:creationId xmlns:a16="http://schemas.microsoft.com/office/drawing/2014/main" id="{66B12D8E-9532-96FE-831A-D38FCA7B4A53}"/>
                  </a:ext>
                </a:extLst>
              </p:cNvPr>
              <p:cNvSpPr/>
              <p:nvPr/>
            </p:nvSpPr>
            <p:spPr>
              <a:xfrm>
                <a:off x="3972232" y="5381296"/>
                <a:ext cx="2157611" cy="160296"/>
              </a:xfrm>
              <a:prstGeom prst="rightArrow">
                <a:avLst>
                  <a:gd name="adj1" fmla="val 72641"/>
                  <a:gd name="adj2" fmla="val 36793"/>
                </a:avLst>
              </a:prstGeom>
              <a:solidFill>
                <a:schemeClr val="bg1"/>
              </a:solidFill>
              <a:ln w="6350">
                <a:solidFill>
                  <a:schemeClr val="tx1">
                    <a:lumMod val="50000"/>
                    <a:lumOff val="50000"/>
                  </a:schemeClr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fr-FR" sz="800" dirty="0">
                    <a:solidFill>
                      <a:schemeClr val="tx1"/>
                    </a:solidFill>
                    <a:latin typeface="Calibri" panose="020F0502020204030204" pitchFamily="34" charset="0"/>
                    <a:cs typeface="Calibri" panose="020F0502020204030204" pitchFamily="34" charset="0"/>
                  </a:rPr>
                  <a:t>Minc3s08477g42291 – 6F06</a:t>
                </a:r>
              </a:p>
            </p:txBody>
          </p:sp>
          <p:sp>
            <p:nvSpPr>
              <p:cNvPr id="30" name="Signalisation droite 29">
                <a:extLst>
                  <a:ext uri="{FF2B5EF4-FFF2-40B4-BE49-F238E27FC236}">
                    <a16:creationId xmlns:a16="http://schemas.microsoft.com/office/drawing/2014/main" id="{31CC7DBE-7B6D-D268-C65D-96572A32D4A0}"/>
                  </a:ext>
                </a:extLst>
              </p:cNvPr>
              <p:cNvSpPr/>
              <p:nvPr/>
            </p:nvSpPr>
            <p:spPr>
              <a:xfrm>
                <a:off x="1401090" y="5372827"/>
                <a:ext cx="48755" cy="180000"/>
              </a:xfrm>
              <a:prstGeom prst="homePlate">
                <a:avLst/>
              </a:prstGeom>
              <a:solidFill>
                <a:srgbClr val="0432FF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GB" sz="8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                </a:t>
                </a:r>
              </a:p>
            </p:txBody>
          </p:sp>
          <p:sp>
            <p:nvSpPr>
              <p:cNvPr id="31" name="Signalisation droite 30">
                <a:extLst>
                  <a:ext uri="{FF2B5EF4-FFF2-40B4-BE49-F238E27FC236}">
                    <a16:creationId xmlns:a16="http://schemas.microsoft.com/office/drawing/2014/main" id="{499059DC-F617-89A8-11F0-E8D2A38D2217}"/>
                  </a:ext>
                </a:extLst>
              </p:cNvPr>
              <p:cNvSpPr/>
              <p:nvPr/>
            </p:nvSpPr>
            <p:spPr>
              <a:xfrm>
                <a:off x="2248136" y="5372827"/>
                <a:ext cx="48755" cy="180000"/>
              </a:xfrm>
              <a:prstGeom prst="homePlate">
                <a:avLst/>
              </a:prstGeom>
              <a:solidFill>
                <a:srgbClr val="73FEFF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GB" sz="8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                </a:t>
                </a:r>
              </a:p>
            </p:txBody>
          </p:sp>
          <p:grpSp>
            <p:nvGrpSpPr>
              <p:cNvPr id="32" name="Groupe 31">
                <a:extLst>
                  <a:ext uri="{FF2B5EF4-FFF2-40B4-BE49-F238E27FC236}">
                    <a16:creationId xmlns:a16="http://schemas.microsoft.com/office/drawing/2014/main" id="{22459C8F-E551-822C-E206-B715649C15E7}"/>
                  </a:ext>
                </a:extLst>
              </p:cNvPr>
              <p:cNvGrpSpPr/>
              <p:nvPr/>
            </p:nvGrpSpPr>
            <p:grpSpPr>
              <a:xfrm>
                <a:off x="3049351" y="5354885"/>
                <a:ext cx="151823" cy="46589"/>
                <a:chOff x="2240672" y="7164749"/>
                <a:chExt cx="698822" cy="214441"/>
              </a:xfrm>
            </p:grpSpPr>
            <p:cxnSp>
              <p:nvCxnSpPr>
                <p:cNvPr id="38" name="Connecteur droit 37">
                  <a:extLst>
                    <a:ext uri="{FF2B5EF4-FFF2-40B4-BE49-F238E27FC236}">
                      <a16:creationId xmlns:a16="http://schemas.microsoft.com/office/drawing/2014/main" id="{0BA8EF4D-C45A-2A59-8B7F-8FDCE421F4D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240672" y="7379190"/>
                  <a:ext cx="662807" cy="0"/>
                </a:xfrm>
                <a:prstGeom prst="line">
                  <a:avLst/>
                </a:prstGeom>
                <a:ln w="15875" cap="rnd">
                  <a:solidFill>
                    <a:schemeClr val="tx1">
                      <a:lumMod val="65000"/>
                      <a:lumOff val="35000"/>
                    </a:schemeClr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9" name="Triangle rectangle 38">
                  <a:extLst>
                    <a:ext uri="{FF2B5EF4-FFF2-40B4-BE49-F238E27FC236}">
                      <a16:creationId xmlns:a16="http://schemas.microsoft.com/office/drawing/2014/main" id="{52210D0A-EB2A-96DF-8809-1595D1B84B55}"/>
                    </a:ext>
                  </a:extLst>
                </p:cNvPr>
                <p:cNvSpPr/>
                <p:nvPr/>
              </p:nvSpPr>
              <p:spPr>
                <a:xfrm>
                  <a:off x="2529299" y="7164749"/>
                  <a:ext cx="410195" cy="204982"/>
                </a:xfrm>
                <a:prstGeom prst="rtTriangle">
                  <a:avLst/>
                </a:prstGeom>
                <a:solidFill>
                  <a:schemeClr val="tx1">
                    <a:lumMod val="65000"/>
                    <a:lumOff val="35000"/>
                  </a:schemeClr>
                </a:solidFill>
                <a:ln>
                  <a:noFill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>
                    <a:latin typeface="Calibri" panose="020F0502020204030204" pitchFamily="34" charset="0"/>
                    <a:cs typeface="Calibri" panose="020F0502020204030204" pitchFamily="34" charset="0"/>
                  </a:endParaRPr>
                </a:p>
              </p:txBody>
            </p:sp>
          </p:grpSp>
          <p:grpSp>
            <p:nvGrpSpPr>
              <p:cNvPr id="33" name="Groupe 32">
                <a:extLst>
                  <a:ext uri="{FF2B5EF4-FFF2-40B4-BE49-F238E27FC236}">
                    <a16:creationId xmlns:a16="http://schemas.microsoft.com/office/drawing/2014/main" id="{252ECF6E-39D3-943C-BFCD-22A66EE9B8CC}"/>
                  </a:ext>
                </a:extLst>
              </p:cNvPr>
              <p:cNvGrpSpPr/>
              <p:nvPr/>
            </p:nvGrpSpPr>
            <p:grpSpPr>
              <a:xfrm rot="10800000">
                <a:off x="5527633" y="5585690"/>
                <a:ext cx="151754" cy="46602"/>
                <a:chOff x="3382660" y="6958418"/>
                <a:chExt cx="698495" cy="214502"/>
              </a:xfrm>
            </p:grpSpPr>
            <p:cxnSp>
              <p:nvCxnSpPr>
                <p:cNvPr id="36" name="Connecteur droit 35">
                  <a:extLst>
                    <a:ext uri="{FF2B5EF4-FFF2-40B4-BE49-F238E27FC236}">
                      <a16:creationId xmlns:a16="http://schemas.microsoft.com/office/drawing/2014/main" id="{92F703E8-597F-6F11-8B90-11AFBF44C7B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382660" y="7172920"/>
                  <a:ext cx="662814" cy="0"/>
                </a:xfrm>
                <a:prstGeom prst="line">
                  <a:avLst/>
                </a:prstGeom>
                <a:ln w="15875" cap="rnd">
                  <a:solidFill>
                    <a:schemeClr val="tx1">
                      <a:lumMod val="65000"/>
                      <a:lumOff val="35000"/>
                    </a:schemeClr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7" name="Triangle rectangle 36">
                  <a:extLst>
                    <a:ext uri="{FF2B5EF4-FFF2-40B4-BE49-F238E27FC236}">
                      <a16:creationId xmlns:a16="http://schemas.microsoft.com/office/drawing/2014/main" id="{D54DCA67-2A27-F522-0CFB-C9C2A3BF3F6C}"/>
                    </a:ext>
                  </a:extLst>
                </p:cNvPr>
                <p:cNvSpPr/>
                <p:nvPr/>
              </p:nvSpPr>
              <p:spPr>
                <a:xfrm>
                  <a:off x="3670969" y="6958418"/>
                  <a:ext cx="410186" cy="204983"/>
                </a:xfrm>
                <a:prstGeom prst="rtTriangle">
                  <a:avLst/>
                </a:prstGeom>
                <a:solidFill>
                  <a:schemeClr val="tx1">
                    <a:lumMod val="65000"/>
                    <a:lumOff val="35000"/>
                  </a:schemeClr>
                </a:solidFill>
                <a:ln>
                  <a:noFill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>
                    <a:latin typeface="Calibri" panose="020F0502020204030204" pitchFamily="34" charset="0"/>
                    <a:cs typeface="Calibri" panose="020F0502020204030204" pitchFamily="34" charset="0"/>
                  </a:endParaRPr>
                </a:p>
              </p:txBody>
            </p:sp>
          </p:grpSp>
          <p:sp>
            <p:nvSpPr>
              <p:cNvPr id="34" name="Flèche vers la gauche 33">
                <a:extLst>
                  <a:ext uri="{FF2B5EF4-FFF2-40B4-BE49-F238E27FC236}">
                    <a16:creationId xmlns:a16="http://schemas.microsoft.com/office/drawing/2014/main" id="{A68F0BC4-750D-140F-8E52-575369E5900C}"/>
                  </a:ext>
                </a:extLst>
              </p:cNvPr>
              <p:cNvSpPr/>
              <p:nvPr/>
            </p:nvSpPr>
            <p:spPr>
              <a:xfrm>
                <a:off x="4809614" y="5648412"/>
                <a:ext cx="296149" cy="108846"/>
              </a:xfrm>
              <a:prstGeom prst="leftArrow">
                <a:avLst>
                  <a:gd name="adj1" fmla="val 100000"/>
                  <a:gd name="adj2" fmla="val 50000"/>
                </a:avLst>
              </a:prstGeom>
              <a:solidFill>
                <a:schemeClr val="bg1"/>
              </a:solidFill>
              <a:ln w="3175">
                <a:solidFill>
                  <a:schemeClr val="tx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vert="horz" lIns="0" tIns="0" rIns="0" bIns="0" rtlCol="0" anchor="ctr"/>
              <a:lstStyle/>
              <a:p>
                <a:pPr algn="ctr"/>
                <a:r>
                  <a:rPr lang="fr-FR" sz="800" dirty="0">
                    <a:solidFill>
                      <a:srgbClr val="FF40FF"/>
                    </a:solidFill>
                    <a:latin typeface="Calibri" panose="020F0502020204030204" pitchFamily="34" charset="0"/>
                    <a:cs typeface="Calibri" panose="020F0502020204030204" pitchFamily="34" charset="0"/>
                  </a:rPr>
                  <a:t>sg2</a:t>
                </a:r>
              </a:p>
            </p:txBody>
          </p:sp>
          <p:sp>
            <p:nvSpPr>
              <p:cNvPr id="35" name="Flèche vers la gauche 34">
                <a:extLst>
                  <a:ext uri="{FF2B5EF4-FFF2-40B4-BE49-F238E27FC236}">
                    <a16:creationId xmlns:a16="http://schemas.microsoft.com/office/drawing/2014/main" id="{63E605B9-4CB0-B6A7-1A29-E190007DDAA4}"/>
                  </a:ext>
                </a:extLst>
              </p:cNvPr>
              <p:cNvSpPr/>
              <p:nvPr/>
            </p:nvSpPr>
            <p:spPr>
              <a:xfrm>
                <a:off x="4857370" y="5532074"/>
                <a:ext cx="296151" cy="114727"/>
              </a:xfrm>
              <a:prstGeom prst="leftArrow">
                <a:avLst>
                  <a:gd name="adj1" fmla="val 100000"/>
                  <a:gd name="adj2" fmla="val 50000"/>
                </a:avLst>
              </a:prstGeom>
              <a:solidFill>
                <a:schemeClr val="bg1"/>
              </a:solidFill>
              <a:ln w="3175">
                <a:solidFill>
                  <a:schemeClr val="tx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vert="horz" lIns="0" tIns="0" rIns="0" bIns="0" rtlCol="0" anchor="ctr"/>
              <a:lstStyle/>
              <a:p>
                <a:pPr algn="ctr"/>
                <a:r>
                  <a:rPr lang="fr-FR" sz="800" dirty="0">
                    <a:solidFill>
                      <a:srgbClr val="FFC000"/>
                    </a:solidFill>
                    <a:latin typeface="Calibri" panose="020F0502020204030204" pitchFamily="34" charset="0"/>
                    <a:cs typeface="Calibri" panose="020F0502020204030204" pitchFamily="34" charset="0"/>
                  </a:rPr>
                  <a:t>sg1</a:t>
                </a:r>
              </a:p>
            </p:txBody>
          </p:sp>
        </p:grpSp>
        <p:grpSp>
          <p:nvGrpSpPr>
            <p:cNvPr id="16" name="Groupe 15">
              <a:extLst>
                <a:ext uri="{FF2B5EF4-FFF2-40B4-BE49-F238E27FC236}">
                  <a16:creationId xmlns:a16="http://schemas.microsoft.com/office/drawing/2014/main" id="{E8474D2A-8459-8476-4484-F05DCEC46D4E}"/>
                </a:ext>
              </a:extLst>
            </p:cNvPr>
            <p:cNvGrpSpPr/>
            <p:nvPr/>
          </p:nvGrpSpPr>
          <p:grpSpPr>
            <a:xfrm>
              <a:off x="2608327" y="474657"/>
              <a:ext cx="3817631" cy="237652"/>
              <a:chOff x="1833486" y="3913570"/>
              <a:chExt cx="4563640" cy="237652"/>
            </a:xfrm>
          </p:grpSpPr>
          <p:cxnSp>
            <p:nvCxnSpPr>
              <p:cNvPr id="17" name="Connecteur droit 16">
                <a:extLst>
                  <a:ext uri="{FF2B5EF4-FFF2-40B4-BE49-F238E27FC236}">
                    <a16:creationId xmlns:a16="http://schemas.microsoft.com/office/drawing/2014/main" id="{CA3F4756-9134-490E-E3C6-964C7639B900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083519" y="4056533"/>
                <a:ext cx="0" cy="90000"/>
              </a:xfrm>
              <a:prstGeom prst="line">
                <a:avLst/>
              </a:prstGeom>
              <a:ln w="6350" cap="rnd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" name="Connecteur droit 17">
                <a:extLst>
                  <a:ext uri="{FF2B5EF4-FFF2-40B4-BE49-F238E27FC236}">
                    <a16:creationId xmlns:a16="http://schemas.microsoft.com/office/drawing/2014/main" id="{11FD111B-C2C5-117D-9E6B-7F554C43D0C3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3440387" y="4056533"/>
                <a:ext cx="0" cy="90000"/>
              </a:xfrm>
              <a:prstGeom prst="line">
                <a:avLst/>
              </a:prstGeom>
              <a:ln w="6350" cap="rnd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" name="Connecteur droit 18">
                <a:extLst>
                  <a:ext uri="{FF2B5EF4-FFF2-40B4-BE49-F238E27FC236}">
                    <a16:creationId xmlns:a16="http://schemas.microsoft.com/office/drawing/2014/main" id="{FCEB8EB9-8C6B-ACF3-DD0F-CFEDD0229256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4803522" y="4056533"/>
                <a:ext cx="0" cy="90000"/>
              </a:xfrm>
              <a:prstGeom prst="line">
                <a:avLst/>
              </a:prstGeom>
              <a:ln w="6350" cap="rnd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" name="Connecteur droit 19">
                <a:extLst>
                  <a:ext uri="{FF2B5EF4-FFF2-40B4-BE49-F238E27FC236}">
                    <a16:creationId xmlns:a16="http://schemas.microsoft.com/office/drawing/2014/main" id="{75741CC9-2555-1325-D5EC-D5A847B8EB6B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6149713" y="4061222"/>
                <a:ext cx="0" cy="90000"/>
              </a:xfrm>
              <a:prstGeom prst="line">
                <a:avLst/>
              </a:prstGeom>
              <a:ln w="6350" cap="rnd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1" name="ZoneTexte 20">
                <a:extLst>
                  <a:ext uri="{FF2B5EF4-FFF2-40B4-BE49-F238E27FC236}">
                    <a16:creationId xmlns:a16="http://schemas.microsoft.com/office/drawing/2014/main" id="{CDECA62F-063E-4D61-E36B-BECB5B22FE2C}"/>
                  </a:ext>
                </a:extLst>
              </p:cNvPr>
              <p:cNvSpPr txBox="1"/>
              <p:nvPr/>
            </p:nvSpPr>
            <p:spPr>
              <a:xfrm>
                <a:off x="1833486" y="3913570"/>
                <a:ext cx="497057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fr-FR" sz="800" i="1" dirty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Calibri" panose="020F0502020204030204" pitchFamily="34" charset="0"/>
                    <a:cs typeface="Calibri" panose="020F0502020204030204" pitchFamily="34" charset="0"/>
                  </a:rPr>
                  <a:t>0.25kb</a:t>
                </a:r>
              </a:p>
            </p:txBody>
          </p:sp>
          <p:sp>
            <p:nvSpPr>
              <p:cNvPr id="22" name="ZoneTexte 21">
                <a:extLst>
                  <a:ext uri="{FF2B5EF4-FFF2-40B4-BE49-F238E27FC236}">
                    <a16:creationId xmlns:a16="http://schemas.microsoft.com/office/drawing/2014/main" id="{3210EE45-124A-E40C-AF87-7B37D51EF0D9}"/>
                  </a:ext>
                </a:extLst>
              </p:cNvPr>
              <p:cNvSpPr txBox="1"/>
              <p:nvPr/>
            </p:nvSpPr>
            <p:spPr>
              <a:xfrm>
                <a:off x="3196828" y="3913570"/>
                <a:ext cx="497057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fr-FR" sz="800" i="1" dirty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Calibri" panose="020F0502020204030204" pitchFamily="34" charset="0"/>
                    <a:cs typeface="Calibri" panose="020F0502020204030204" pitchFamily="34" charset="0"/>
                  </a:rPr>
                  <a:t>0.5kb</a:t>
                </a:r>
              </a:p>
            </p:txBody>
          </p:sp>
          <p:sp>
            <p:nvSpPr>
              <p:cNvPr id="23" name="ZoneTexte 22">
                <a:extLst>
                  <a:ext uri="{FF2B5EF4-FFF2-40B4-BE49-F238E27FC236}">
                    <a16:creationId xmlns:a16="http://schemas.microsoft.com/office/drawing/2014/main" id="{B8283A98-4E62-8D39-9204-FC6B83318006}"/>
                  </a:ext>
                </a:extLst>
              </p:cNvPr>
              <p:cNvSpPr txBox="1"/>
              <p:nvPr/>
            </p:nvSpPr>
            <p:spPr>
              <a:xfrm>
                <a:off x="4559961" y="3913570"/>
                <a:ext cx="497057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fr-FR" sz="800" i="1" dirty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Calibri" panose="020F0502020204030204" pitchFamily="34" charset="0"/>
                    <a:cs typeface="Calibri" panose="020F0502020204030204" pitchFamily="34" charset="0"/>
                  </a:rPr>
                  <a:t>0.75kb</a:t>
                </a:r>
              </a:p>
            </p:txBody>
          </p:sp>
          <p:sp>
            <p:nvSpPr>
              <p:cNvPr id="24" name="ZoneTexte 23">
                <a:extLst>
                  <a:ext uri="{FF2B5EF4-FFF2-40B4-BE49-F238E27FC236}">
                    <a16:creationId xmlns:a16="http://schemas.microsoft.com/office/drawing/2014/main" id="{F5C2FE20-5A7D-130C-99B7-4C37585A33FC}"/>
                  </a:ext>
                </a:extLst>
              </p:cNvPr>
              <p:cNvSpPr txBox="1"/>
              <p:nvPr/>
            </p:nvSpPr>
            <p:spPr>
              <a:xfrm>
                <a:off x="5900069" y="3913570"/>
                <a:ext cx="497057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fr-FR" sz="800" i="1" dirty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Calibri" panose="020F0502020204030204" pitchFamily="34" charset="0"/>
                    <a:cs typeface="Calibri" panose="020F0502020204030204" pitchFamily="34" charset="0"/>
                  </a:rPr>
                  <a:t>1kb</a:t>
                </a:r>
              </a:p>
            </p:txBody>
          </p:sp>
        </p:grpSp>
      </p:grpSp>
      <p:sp>
        <p:nvSpPr>
          <p:cNvPr id="40" name="ZoneTexte 39">
            <a:extLst>
              <a:ext uri="{FF2B5EF4-FFF2-40B4-BE49-F238E27FC236}">
                <a16:creationId xmlns:a16="http://schemas.microsoft.com/office/drawing/2014/main" id="{10C83E57-45BC-6EDC-C19C-4535BA8ACD0B}"/>
              </a:ext>
            </a:extLst>
          </p:cNvPr>
          <p:cNvSpPr txBox="1"/>
          <p:nvPr/>
        </p:nvSpPr>
        <p:spPr>
          <a:xfrm>
            <a:off x="484891" y="1856022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Calibri" panose="020F0502020204030204" pitchFamily="34" charset="0"/>
                <a:cs typeface="Calibri" panose="020F0502020204030204" pitchFamily="34" charset="0"/>
              </a:rPr>
              <a:t>B</a:t>
            </a:r>
          </a:p>
        </p:txBody>
      </p:sp>
      <p:sp>
        <p:nvSpPr>
          <p:cNvPr id="41" name="ZoneTexte 40">
            <a:extLst>
              <a:ext uri="{FF2B5EF4-FFF2-40B4-BE49-F238E27FC236}">
                <a16:creationId xmlns:a16="http://schemas.microsoft.com/office/drawing/2014/main" id="{67EC9B9E-3500-3FE9-6857-2D21E6DF6A31}"/>
              </a:ext>
            </a:extLst>
          </p:cNvPr>
          <p:cNvSpPr txBox="1"/>
          <p:nvPr/>
        </p:nvSpPr>
        <p:spPr>
          <a:xfrm rot="10800000" flipV="1">
            <a:off x="-1" y="3797343"/>
            <a:ext cx="6816061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fr-FR" sz="900" b="1" dirty="0" err="1">
                <a:latin typeface="Calibri" panose="020F0502020204030204" pitchFamily="34" charset="0"/>
                <a:cs typeface="Calibri" panose="020F0502020204030204" pitchFamily="34" charset="0"/>
              </a:rPr>
              <a:t>Supplementary</a:t>
            </a:r>
            <a:r>
              <a:rPr lang="fr-FR" sz="900" b="1" dirty="0">
                <a:latin typeface="Calibri" panose="020F0502020204030204" pitchFamily="34" charset="0"/>
                <a:cs typeface="Calibri" panose="020F0502020204030204" pitchFamily="34" charset="0"/>
              </a:rPr>
              <a:t> Figure S5</a:t>
            </a:r>
            <a:r>
              <a:rPr lang="fr-FR" sz="900" b="1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. </a:t>
            </a:r>
            <a:r>
              <a:rPr lang="fr-FR" sz="900" b="1" i="1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in vitro</a:t>
            </a:r>
            <a:r>
              <a:rPr lang="fr-FR" sz="900" b="1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fr-FR" sz="900" b="1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Cas9 </a:t>
            </a:r>
            <a:r>
              <a:rPr lang="fr-FR" sz="900" b="1" dirty="0" err="1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assay</a:t>
            </a:r>
            <a:r>
              <a:rPr lang="fr-FR" sz="900" b="1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to </a:t>
            </a:r>
            <a:r>
              <a:rPr lang="fr-FR" sz="900" b="1" dirty="0" err="1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assess</a:t>
            </a:r>
            <a:r>
              <a:rPr lang="fr-FR" sz="900" b="1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the </a:t>
            </a:r>
            <a:r>
              <a:rPr lang="fr-FR" sz="900" b="1" dirty="0" err="1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cleveage</a:t>
            </a:r>
            <a:r>
              <a:rPr lang="fr-FR" sz="900" b="1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fr-FR" sz="900" b="1" dirty="0" err="1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efficiency</a:t>
            </a:r>
            <a:r>
              <a:rPr lang="fr-FR" sz="900" b="1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fr-FR" sz="900" b="1" dirty="0" err="1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from</a:t>
            </a:r>
            <a:r>
              <a:rPr lang="fr-FR" sz="900" b="1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fr-FR" sz="900" b="1" dirty="0" err="1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chosen</a:t>
            </a:r>
            <a:r>
              <a:rPr lang="fr-FR" sz="900" b="1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fr-FR" sz="900" b="1" dirty="0" err="1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sgRNAs</a:t>
            </a:r>
            <a:r>
              <a:rPr lang="fr-FR" sz="900" b="1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fr-FR" sz="900" b="1" dirty="0" err="1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targeting</a:t>
            </a:r>
            <a:r>
              <a:rPr lang="fr-FR" sz="900" b="1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PCR-</a:t>
            </a:r>
            <a:r>
              <a:rPr lang="fr-FR" sz="900" b="1" dirty="0" err="1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amplified</a:t>
            </a:r>
            <a:r>
              <a:rPr lang="fr-FR" sz="900" b="1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6F06 locus</a:t>
            </a:r>
            <a:r>
              <a:rPr lang="fr-FR" sz="900" b="1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fr-FR" sz="9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(</a:t>
            </a:r>
            <a:r>
              <a:rPr lang="fr-FR" sz="900" b="1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A</a:t>
            </a:r>
            <a:r>
              <a:rPr lang="fr-FR" sz="9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) </a:t>
            </a:r>
            <a:r>
              <a:rPr lang="fr-FR" sz="900" b="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Map</a:t>
            </a:r>
            <a:r>
              <a:rPr lang="fr-FR" sz="9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of the 6F06 </a:t>
            </a:r>
            <a:r>
              <a:rPr lang="fr-FR" sz="900" b="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effector</a:t>
            </a:r>
            <a:r>
              <a:rPr lang="fr-FR" sz="9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fr-FR" sz="900" b="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genomic</a:t>
            </a:r>
            <a:r>
              <a:rPr lang="fr-FR" sz="9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locus (Minc3s08477g42291), </a:t>
            </a:r>
            <a:r>
              <a:rPr lang="fr-FR" sz="900" b="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showing</a:t>
            </a:r>
            <a:r>
              <a:rPr lang="fr-FR" sz="9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the </a:t>
            </a:r>
            <a:r>
              <a:rPr lang="fr-FR" sz="900" b="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regions</a:t>
            </a:r>
            <a:r>
              <a:rPr lang="fr-FR" sz="9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fr-FR" sz="900" b="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targeted</a:t>
            </a:r>
            <a:r>
              <a:rPr lang="fr-FR" sz="9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by </a:t>
            </a:r>
            <a:r>
              <a:rPr lang="fr-FR" sz="900" b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the recombinant Cas9/</a:t>
            </a:r>
            <a:r>
              <a:rPr lang="fr-FR" sz="900" b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sgRNA</a:t>
            </a:r>
            <a:r>
              <a:rPr lang="fr-FR" sz="900" b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complexes</a:t>
            </a:r>
            <a:r>
              <a:rPr lang="fr-FR" sz="9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. The </a:t>
            </a:r>
            <a:r>
              <a:rPr lang="fr-FR" sz="900" b="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promoter</a:t>
            </a:r>
            <a:r>
              <a:rPr lang="fr-FR" sz="9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fr-FR" sz="900" b="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region</a:t>
            </a:r>
            <a:r>
              <a:rPr lang="fr-FR" sz="9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fr-FR" sz="900" b="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contains</a:t>
            </a:r>
            <a:r>
              <a:rPr lang="fr-FR" sz="9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Mel-DOG boxes, </a:t>
            </a:r>
            <a:r>
              <a:rPr lang="fr-FR" sz="900" b="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existing</a:t>
            </a:r>
            <a:r>
              <a:rPr lang="fr-FR" sz="9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in </a:t>
            </a:r>
            <a:r>
              <a:rPr lang="fr-FR" sz="900" b="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two</a:t>
            </a:r>
            <a:r>
              <a:rPr lang="fr-FR" sz="9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variants (</a:t>
            </a:r>
            <a:r>
              <a:rPr lang="fr-FR" sz="900" b="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blue</a:t>
            </a:r>
            <a:r>
              <a:rPr lang="fr-FR" sz="9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and turquoise </a:t>
            </a:r>
            <a:r>
              <a:rPr lang="fr-FR" sz="900" b="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arrows</a:t>
            </a:r>
            <a:r>
              <a:rPr lang="fr-FR" sz="9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). The 6F06 </a:t>
            </a:r>
            <a:r>
              <a:rPr lang="fr-FR" sz="900" b="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promoter</a:t>
            </a:r>
            <a:r>
              <a:rPr lang="fr-FR" sz="9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fr-FR" sz="900" b="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region</a:t>
            </a:r>
            <a:r>
              <a:rPr lang="fr-FR" sz="9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fr-FR" sz="900" b="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is</a:t>
            </a:r>
            <a:r>
              <a:rPr lang="fr-FR" sz="9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fr-FR" sz="900" b="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targeted</a:t>
            </a:r>
            <a:r>
              <a:rPr lang="fr-FR" sz="9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fr-FR" sz="900" b="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with</a:t>
            </a:r>
            <a:r>
              <a:rPr lang="fr-FR" sz="9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fr-FR" sz="900" b="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two</a:t>
            </a:r>
            <a:r>
              <a:rPr lang="fr-FR" sz="9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fr-FR" sz="900" b="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ribonucleoprotein</a:t>
            </a:r>
            <a:r>
              <a:rPr lang="fr-FR" sz="9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(RNP) complexes, </a:t>
            </a:r>
            <a:r>
              <a:rPr lang="fr-FR" sz="900" b="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each</a:t>
            </a:r>
            <a:r>
              <a:rPr lang="fr-FR" sz="9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fr-FR" sz="900" b="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composed</a:t>
            </a:r>
            <a:r>
              <a:rPr lang="fr-FR" sz="9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of the active </a:t>
            </a:r>
            <a:r>
              <a:rPr lang="fr-FR" sz="900" b="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form</a:t>
            </a:r>
            <a:r>
              <a:rPr lang="fr-FR" sz="9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of Cas9 and a </a:t>
            </a:r>
            <a:r>
              <a:rPr lang="fr-FR" sz="900" b="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specific</a:t>
            </a:r>
            <a:r>
              <a:rPr lang="fr-FR" sz="9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fr-FR" sz="900" b="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sgRNA</a:t>
            </a:r>
            <a:r>
              <a:rPr lang="fr-FR" sz="9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( (sg1 and sg2), </a:t>
            </a:r>
            <a:r>
              <a:rPr lang="fr-FR" sz="900" b="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with</a:t>
            </a:r>
            <a:r>
              <a:rPr lang="fr-FR" sz="9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fr-FR" sz="900" b="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their</a:t>
            </a:r>
            <a:r>
              <a:rPr lang="fr-FR" sz="9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positions are </a:t>
            </a:r>
            <a:r>
              <a:rPr lang="fr-FR" sz="900" b="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indicated</a:t>
            </a:r>
            <a:r>
              <a:rPr lang="fr-FR" sz="9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. PCR amplification </a:t>
            </a:r>
            <a:r>
              <a:rPr lang="fr-FR" sz="900" b="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was</a:t>
            </a:r>
            <a:r>
              <a:rPr lang="fr-FR" sz="9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fr-FR" sz="900" b="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performed</a:t>
            </a:r>
            <a:r>
              <a:rPr lang="fr-FR" sz="9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fr-FR" sz="900" b="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using</a:t>
            </a:r>
            <a:r>
              <a:rPr lang="fr-FR" sz="9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fr-FR" sz="900" dirty="0" err="1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flanking</a:t>
            </a:r>
            <a:r>
              <a:rPr lang="fr-FR" sz="9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fr-FR" sz="900" dirty="0" err="1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rimers</a:t>
            </a:r>
            <a:r>
              <a:rPr lang="fr-FR" sz="9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(</a:t>
            </a:r>
            <a:r>
              <a:rPr lang="fr-FR" sz="900" dirty="0" err="1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grey</a:t>
            </a:r>
            <a:r>
              <a:rPr lang="fr-FR" sz="9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fr-FR" sz="900" dirty="0" err="1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arrows</a:t>
            </a:r>
            <a:r>
              <a:rPr lang="fr-FR" sz="9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)</a:t>
            </a:r>
            <a:r>
              <a:rPr lang="fr-FR" sz="9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to </a:t>
            </a:r>
            <a:r>
              <a:rPr lang="fr-FR" sz="900" b="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generate</a:t>
            </a:r>
            <a:r>
              <a:rPr lang="fr-FR" sz="9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the DNA </a:t>
            </a:r>
            <a:r>
              <a:rPr lang="fr-FR" sz="900" b="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template</a:t>
            </a:r>
            <a:r>
              <a:rPr lang="fr-FR" sz="9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for the </a:t>
            </a:r>
            <a:r>
              <a:rPr lang="fr-FR" sz="900" b="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assay</a:t>
            </a:r>
            <a:r>
              <a:rPr lang="fr-FR" sz="9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(</a:t>
            </a:r>
            <a:r>
              <a:rPr lang="fr-FR" sz="900" b="1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B</a:t>
            </a:r>
            <a:r>
              <a:rPr lang="fr-FR" sz="9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) </a:t>
            </a:r>
            <a:r>
              <a:rPr lang="fr-FR" sz="900" b="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Representative</a:t>
            </a:r>
            <a:r>
              <a:rPr lang="fr-FR" sz="9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agarose gel </a:t>
            </a:r>
            <a:r>
              <a:rPr lang="fr-FR" sz="900" b="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showing</a:t>
            </a:r>
            <a:r>
              <a:rPr lang="fr-FR" sz="9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fr-FR" sz="900" b="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results</a:t>
            </a:r>
            <a:r>
              <a:rPr lang="fr-FR" sz="9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fr-FR" sz="900" b="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from</a:t>
            </a:r>
            <a:r>
              <a:rPr lang="fr-FR" sz="9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fr-FR" sz="900" b="0" i="1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in vitro </a:t>
            </a:r>
            <a:r>
              <a:rPr lang="fr-FR" sz="9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digestion </a:t>
            </a:r>
            <a:r>
              <a:rPr lang="fr-FR" sz="900" b="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assays</a:t>
            </a:r>
            <a:r>
              <a:rPr lang="fr-FR" sz="9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fr-FR" sz="900" b="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testing</a:t>
            </a:r>
            <a:r>
              <a:rPr lang="fr-FR" sz="9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the </a:t>
            </a:r>
            <a:r>
              <a:rPr lang="fr-FR" sz="900" b="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cleavage</a:t>
            </a:r>
            <a:r>
              <a:rPr lang="fr-FR" sz="9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fr-FR" sz="900" b="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efficiency</a:t>
            </a:r>
            <a:r>
              <a:rPr lang="fr-FR" sz="9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of </a:t>
            </a:r>
            <a:r>
              <a:rPr lang="fr-FR" sz="900" b="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two</a:t>
            </a:r>
            <a:r>
              <a:rPr lang="fr-FR" sz="9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fr-FR" sz="900" b="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sgRNAs</a:t>
            </a:r>
            <a:r>
              <a:rPr lang="fr-FR" sz="9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fr-FR" sz="900" b="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targeting</a:t>
            </a:r>
            <a:r>
              <a:rPr lang="fr-FR" sz="9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the PCR-</a:t>
            </a:r>
            <a:r>
              <a:rPr lang="fr-FR" sz="900" b="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amplified</a:t>
            </a:r>
            <a:r>
              <a:rPr lang="fr-FR" sz="9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6F06 locus. </a:t>
            </a:r>
            <a:r>
              <a:rPr lang="fr-FR" sz="900" b="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Purified</a:t>
            </a:r>
            <a:r>
              <a:rPr lang="fr-FR" sz="9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PCR </a:t>
            </a:r>
            <a:r>
              <a:rPr lang="fr-FR" sz="9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matrices</a:t>
            </a:r>
            <a:r>
              <a:rPr lang="fr-FR" sz="9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fr-FR" sz="900" b="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incubated</a:t>
            </a:r>
            <a:r>
              <a:rPr lang="fr-FR" sz="9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fr-FR" sz="900" b="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with</a:t>
            </a:r>
            <a:r>
              <a:rPr lang="fr-FR" sz="9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recombinant Cas9 </a:t>
            </a:r>
            <a:r>
              <a:rPr lang="fr-FR" sz="900" b="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protein</a:t>
            </a:r>
            <a:r>
              <a:rPr lang="fr-FR" sz="9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fr-FR" sz="900" b="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lacking</a:t>
            </a:r>
            <a:r>
              <a:rPr lang="fr-FR" sz="9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a </a:t>
            </a:r>
            <a:r>
              <a:rPr lang="fr-FR" sz="900" b="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specific</a:t>
            </a:r>
            <a:r>
              <a:rPr lang="fr-FR" sz="9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fr-FR" sz="900" b="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sgRNA</a:t>
            </a:r>
            <a:r>
              <a:rPr lang="fr-FR" sz="9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(-) </a:t>
            </a:r>
            <a:r>
              <a:rPr lang="fr-FR" sz="900" b="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showed</a:t>
            </a:r>
            <a:r>
              <a:rPr lang="fr-FR" sz="9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no </a:t>
            </a:r>
            <a:r>
              <a:rPr lang="fr-FR" sz="900" b="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cleveage</a:t>
            </a:r>
            <a:r>
              <a:rPr lang="fr-FR" sz="9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, </a:t>
            </a:r>
            <a:r>
              <a:rPr lang="fr-FR" sz="900" b="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while</a:t>
            </a:r>
            <a:r>
              <a:rPr lang="fr-FR" sz="9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the addition of </a:t>
            </a:r>
            <a:r>
              <a:rPr lang="fr-FR" sz="900" b="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sgRNA</a:t>
            </a:r>
            <a:r>
              <a:rPr lang="fr-FR" sz="9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/Cas9 complexes </a:t>
            </a:r>
            <a:r>
              <a:rPr lang="fr-FR" sz="900" b="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led</a:t>
            </a:r>
            <a:r>
              <a:rPr lang="fr-FR" sz="9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to </a:t>
            </a:r>
            <a:r>
              <a:rPr lang="fr-FR" sz="900" b="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moderate</a:t>
            </a:r>
            <a:r>
              <a:rPr lang="fr-FR" sz="9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fr-FR" sz="900" b="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cleavage</a:t>
            </a:r>
            <a:r>
              <a:rPr lang="fr-FR" sz="9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of the </a:t>
            </a:r>
            <a:r>
              <a:rPr lang="fr-FR" sz="900" dirty="0" err="1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target</a:t>
            </a:r>
            <a:r>
              <a:rPr lang="fr-FR" sz="9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PCR </a:t>
            </a:r>
            <a:r>
              <a:rPr lang="fr-FR" sz="900" dirty="0" err="1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roduct</a:t>
            </a:r>
            <a:r>
              <a:rPr lang="fr-FR" sz="9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. M = 1 kb DNA ladder.</a:t>
            </a:r>
            <a:endParaRPr lang="fr-FR" sz="900" b="0" i="0" u="none" strike="noStrike" dirty="0">
              <a:solidFill>
                <a:srgbClr val="000000"/>
              </a:solidFill>
              <a:effectLst/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4" name="ZoneTexte 43">
            <a:extLst>
              <a:ext uri="{FF2B5EF4-FFF2-40B4-BE49-F238E27FC236}">
                <a16:creationId xmlns:a16="http://schemas.microsoft.com/office/drawing/2014/main" id="{578F0CFC-E526-4C2D-602E-226F8849791C}"/>
              </a:ext>
            </a:extLst>
          </p:cNvPr>
          <p:cNvSpPr txBox="1"/>
          <p:nvPr/>
        </p:nvSpPr>
        <p:spPr>
          <a:xfrm>
            <a:off x="2528537" y="3281642"/>
            <a:ext cx="39305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>
                <a:latin typeface="Calibri" panose="020F0502020204030204" pitchFamily="34" charset="0"/>
                <a:cs typeface="Calibri" panose="020F0502020204030204" pitchFamily="34" charset="0"/>
              </a:rPr>
              <a:t>- 500</a:t>
            </a:r>
          </a:p>
        </p:txBody>
      </p:sp>
      <p:sp>
        <p:nvSpPr>
          <p:cNvPr id="45" name="ZoneTexte 44">
            <a:extLst>
              <a:ext uri="{FF2B5EF4-FFF2-40B4-BE49-F238E27FC236}">
                <a16:creationId xmlns:a16="http://schemas.microsoft.com/office/drawing/2014/main" id="{36D79C2B-1EB9-C654-2C48-B5706B5DFF35}"/>
              </a:ext>
            </a:extLst>
          </p:cNvPr>
          <p:cNvSpPr txBox="1"/>
          <p:nvPr/>
        </p:nvSpPr>
        <p:spPr>
          <a:xfrm>
            <a:off x="2528537" y="3469136"/>
            <a:ext cx="39305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>
                <a:latin typeface="Calibri" panose="020F0502020204030204" pitchFamily="34" charset="0"/>
                <a:cs typeface="Calibri" panose="020F0502020204030204" pitchFamily="34" charset="0"/>
              </a:rPr>
              <a:t>- 100</a:t>
            </a:r>
          </a:p>
        </p:txBody>
      </p:sp>
      <p:sp>
        <p:nvSpPr>
          <p:cNvPr id="46" name="ZoneTexte 45">
            <a:extLst>
              <a:ext uri="{FF2B5EF4-FFF2-40B4-BE49-F238E27FC236}">
                <a16:creationId xmlns:a16="http://schemas.microsoft.com/office/drawing/2014/main" id="{2239B4EA-BE1B-62AB-C44F-E2569980F4FD}"/>
              </a:ext>
            </a:extLst>
          </p:cNvPr>
          <p:cNvSpPr txBox="1"/>
          <p:nvPr/>
        </p:nvSpPr>
        <p:spPr>
          <a:xfrm>
            <a:off x="2528537" y="3157382"/>
            <a:ext cx="44435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>
                <a:latin typeface="Calibri" panose="020F0502020204030204" pitchFamily="34" charset="0"/>
                <a:cs typeface="Calibri" panose="020F0502020204030204" pitchFamily="34" charset="0"/>
              </a:rPr>
              <a:t>- 1000</a:t>
            </a:r>
          </a:p>
        </p:txBody>
      </p:sp>
      <p:sp>
        <p:nvSpPr>
          <p:cNvPr id="47" name="ZoneTexte 46">
            <a:extLst>
              <a:ext uri="{FF2B5EF4-FFF2-40B4-BE49-F238E27FC236}">
                <a16:creationId xmlns:a16="http://schemas.microsoft.com/office/drawing/2014/main" id="{504DC739-9BB5-DD35-EBA8-B47A2CED4152}"/>
              </a:ext>
            </a:extLst>
          </p:cNvPr>
          <p:cNvSpPr txBox="1"/>
          <p:nvPr/>
        </p:nvSpPr>
        <p:spPr>
          <a:xfrm>
            <a:off x="2533108" y="2953350"/>
            <a:ext cx="44435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>
                <a:latin typeface="Calibri" panose="020F0502020204030204" pitchFamily="34" charset="0"/>
                <a:cs typeface="Calibri" panose="020F0502020204030204" pitchFamily="34" charset="0"/>
              </a:rPr>
              <a:t>- 3000</a:t>
            </a:r>
          </a:p>
        </p:txBody>
      </p:sp>
      <p:sp>
        <p:nvSpPr>
          <p:cNvPr id="48" name="ZoneTexte 47">
            <a:extLst>
              <a:ext uri="{FF2B5EF4-FFF2-40B4-BE49-F238E27FC236}">
                <a16:creationId xmlns:a16="http://schemas.microsoft.com/office/drawing/2014/main" id="{C2A93652-764F-0A43-E531-2A034D0DE7B8}"/>
              </a:ext>
            </a:extLst>
          </p:cNvPr>
          <p:cNvSpPr txBox="1"/>
          <p:nvPr/>
        </p:nvSpPr>
        <p:spPr>
          <a:xfrm>
            <a:off x="2558208" y="2603591"/>
            <a:ext cx="29367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>
                <a:latin typeface="Calibri" panose="020F0502020204030204" pitchFamily="34" charset="0"/>
                <a:cs typeface="Calibri" panose="020F0502020204030204" pitchFamily="34" charset="0"/>
              </a:rPr>
              <a:t>bp</a:t>
            </a:r>
          </a:p>
        </p:txBody>
      </p:sp>
    </p:spTree>
    <p:extLst>
      <p:ext uri="{BB962C8B-B14F-4D97-AF65-F5344CB8AC3E}">
        <p14:creationId xmlns:p14="http://schemas.microsoft.com/office/powerpoint/2010/main" val="306964217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067</TotalTime>
  <Words>245</Words>
  <Application>Microsoft Macintosh PowerPoint</Application>
  <PresentationFormat>Affichage à l'écran (4:3)</PresentationFormat>
  <Paragraphs>44</Paragraphs>
  <Slides>1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2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4" baseType="lpstr">
      <vt:lpstr>Arial</vt:lpstr>
      <vt:lpstr>Calibri</vt:lpstr>
      <vt:lpstr>Thème Office</vt:lpstr>
      <vt:lpstr>Présentation PowerPoint</vt:lpstr>
    </vt:vector>
  </TitlesOfParts>
  <Company>Nen'apa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François-Xavier GILLET</dc:creator>
  <cp:lastModifiedBy>caroline bournaud</cp:lastModifiedBy>
  <cp:revision>408</cp:revision>
  <dcterms:created xsi:type="dcterms:W3CDTF">2017-12-07T17:16:40Z</dcterms:created>
  <dcterms:modified xsi:type="dcterms:W3CDTF">2025-06-30T12:08:14Z</dcterms:modified>
</cp:coreProperties>
</file>